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9" r:id="rId2"/>
  </p:sldIdLst>
  <p:sldSz cx="9144000" cy="6858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4890" autoAdjust="0"/>
    <p:restoredTop sz="94619" autoAdjust="0"/>
  </p:normalViewPr>
  <p:slideViewPr>
    <p:cSldViewPr>
      <p:cViewPr>
        <p:scale>
          <a:sx n="80" d="100"/>
          <a:sy n="80" d="100"/>
        </p:scale>
        <p:origin x="-1416" y="-63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1968" cy="465296"/>
          </a:xfrm>
          <a:prstGeom prst="rect">
            <a:avLst/>
          </a:prstGeom>
        </p:spPr>
        <p:txBody>
          <a:bodyPr vert="horz" lIns="93279" tIns="46640" rIns="93279" bIns="4664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3" y="0"/>
            <a:ext cx="3041968" cy="465296"/>
          </a:xfrm>
          <a:prstGeom prst="rect">
            <a:avLst/>
          </a:prstGeom>
        </p:spPr>
        <p:txBody>
          <a:bodyPr vert="horz" lIns="93279" tIns="46640" rIns="93279" bIns="46640" rtlCol="0"/>
          <a:lstStyle>
            <a:lvl1pPr algn="r">
              <a:defRPr sz="1200"/>
            </a:lvl1pPr>
          </a:lstStyle>
          <a:p>
            <a:fld id="{9F2568DF-276F-451E-9826-FA02DE1B7B48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2688" y="696913"/>
            <a:ext cx="4654550" cy="34909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79" tIns="46640" rIns="93279" bIns="4664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20315"/>
            <a:ext cx="5615940" cy="4187666"/>
          </a:xfrm>
          <a:prstGeom prst="rect">
            <a:avLst/>
          </a:prstGeom>
        </p:spPr>
        <p:txBody>
          <a:bodyPr vert="horz" lIns="93279" tIns="46640" rIns="93279" bIns="4664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4"/>
            <a:ext cx="3041968" cy="465296"/>
          </a:xfrm>
          <a:prstGeom prst="rect">
            <a:avLst/>
          </a:prstGeom>
        </p:spPr>
        <p:txBody>
          <a:bodyPr vert="horz" lIns="93279" tIns="46640" rIns="93279" bIns="4664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3" y="8839014"/>
            <a:ext cx="3041968" cy="465296"/>
          </a:xfrm>
          <a:prstGeom prst="rect">
            <a:avLst/>
          </a:prstGeom>
        </p:spPr>
        <p:txBody>
          <a:bodyPr vert="horz" lIns="93279" tIns="46640" rIns="93279" bIns="46640" rtlCol="0" anchor="b"/>
          <a:lstStyle>
            <a:lvl1pPr algn="r">
              <a:defRPr sz="1200"/>
            </a:lvl1pPr>
          </a:lstStyle>
          <a:p>
            <a:fld id="{F8478FF9-06CF-4A5E-B360-824A2CE377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72796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44FA8-D812-45FE-9C28-CFA425CAF12D}" type="datetime1">
              <a:rPr lang="en-US" smtClean="0"/>
              <a:t>8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A6EBA-0C45-4C2A-9767-16668B3AF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3488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8F882-8DC9-4104-A3E3-2E89B1DB8CAC}" type="datetime1">
              <a:rPr lang="en-US" smtClean="0"/>
              <a:t>8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A6EBA-0C45-4C2A-9767-16668B3AF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78926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EE3C0-160A-4ECE-A683-5DE134B6AF06}" type="datetime1">
              <a:rPr lang="en-US" smtClean="0"/>
              <a:t>8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A6EBA-0C45-4C2A-9767-16668B3AF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7673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CDB78-1AB6-483B-85B3-7698C72E0503}" type="datetime1">
              <a:rPr lang="en-US" smtClean="0"/>
              <a:t>8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A6EBA-0C45-4C2A-9767-16668B3AF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6000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E36C9-CB19-4A26-80F8-2C3929E805E4}" type="datetime1">
              <a:rPr lang="en-US" smtClean="0"/>
              <a:t>8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A6EBA-0C45-4C2A-9767-16668B3AF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6920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57F4E-57F4-4BE3-A4A5-9DC22607135A}" type="datetime1">
              <a:rPr lang="en-US" smtClean="0"/>
              <a:t>8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A6EBA-0C45-4C2A-9767-16668B3AF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8224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051DA-FAE4-4BD2-9CF8-E153F96E76C9}" type="datetime1">
              <a:rPr lang="en-US" smtClean="0"/>
              <a:t>8/1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A6EBA-0C45-4C2A-9767-16668B3AF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7307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58B98-0764-46AF-B367-72DDE3C70DCC}" type="datetime1">
              <a:rPr lang="en-US" smtClean="0"/>
              <a:t>8/1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A6EBA-0C45-4C2A-9767-16668B3AF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9751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F708D-8FCC-41CA-8D8A-3BDD32B06C5B}" type="datetime1">
              <a:rPr lang="en-US" smtClean="0"/>
              <a:t>8/1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A6EBA-0C45-4C2A-9767-16668B3AF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7600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50646-214B-47B4-BBDD-0A5E76498B0B}" type="datetime1">
              <a:rPr lang="en-US" smtClean="0"/>
              <a:t>8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A6EBA-0C45-4C2A-9767-16668B3AF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4467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64D672-FF58-49D8-B06E-B846B9D72818}" type="datetime1">
              <a:rPr lang="en-US" smtClean="0"/>
              <a:t>8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A6EBA-0C45-4C2A-9767-16668B3AF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547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4C12F9-B035-4353-9807-27F4155EBBAD}" type="datetime1">
              <a:rPr lang="en-US" smtClean="0"/>
              <a:t>8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FA6EBA-0C45-4C2A-9767-16668B3AF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835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A6EBA-0C45-4C2A-9767-16668B3AFD64}" type="slidenum">
              <a:rPr lang="en-US" smtClean="0"/>
              <a:t>1</a:t>
            </a:fld>
            <a:endParaRPr lang="en-US"/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24691" y="1143000"/>
            <a:ext cx="4687888" cy="41543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Rectangle 2"/>
          <p:cNvSpPr/>
          <p:nvPr/>
        </p:nvSpPr>
        <p:spPr>
          <a:xfrm>
            <a:off x="37605" y="5715000"/>
            <a:ext cx="866206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smtClean="0"/>
              <a:t>Table S1</a:t>
            </a:r>
            <a:r>
              <a:rPr lang="en-US" sz="1600" b="1" dirty="0"/>
              <a:t>:</a:t>
            </a:r>
            <a:r>
              <a:rPr lang="en-US" sz="1600" dirty="0"/>
              <a:t> </a:t>
            </a:r>
            <a:r>
              <a:rPr lang="en-US" sz="1600" b="1" dirty="0"/>
              <a:t>Multivariate analysis of clinicopathologic features and the three ampullary subtyping methods.</a:t>
            </a:r>
            <a:r>
              <a:rPr lang="en-US" sz="1600" dirty="0"/>
              <a:t> Abbreviations: HR, hazard ratio; CI, confidence interval; Int, Intestinal; </a:t>
            </a:r>
            <a:r>
              <a:rPr lang="en-US" sz="1600" dirty="0" err="1"/>
              <a:t>Pb</a:t>
            </a:r>
            <a:r>
              <a:rPr lang="en-US" sz="1600" dirty="0"/>
              <a:t>, Pancreaticobiliary; Non-</a:t>
            </a:r>
            <a:r>
              <a:rPr lang="en-US" sz="1600" dirty="0" err="1"/>
              <a:t>Pb</a:t>
            </a:r>
            <a:r>
              <a:rPr lang="en-US" sz="1600" dirty="0"/>
              <a:t>, Non-pancreaticobiliary.</a:t>
            </a:r>
          </a:p>
        </p:txBody>
      </p:sp>
    </p:spTree>
    <p:extLst>
      <p:ext uri="{BB962C8B-B14F-4D97-AF65-F5344CB8AC3E}">
        <p14:creationId xmlns:p14="http://schemas.microsoft.com/office/powerpoint/2010/main" val="38961729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96</TotalTime>
  <Words>40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ris Soifer</dc:creator>
  <cp:lastModifiedBy>Abella, Jerard Dave</cp:lastModifiedBy>
  <cp:revision>61</cp:revision>
  <cp:lastPrinted>2015-10-01T19:13:06Z</cp:lastPrinted>
  <dcterms:created xsi:type="dcterms:W3CDTF">2015-06-23T21:10:52Z</dcterms:created>
  <dcterms:modified xsi:type="dcterms:W3CDTF">2016-08-10T10:55:15Z</dcterms:modified>
</cp:coreProperties>
</file>